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36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3E799-31A0-471A-9F63-84B0B3D510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6CFF5F-75BF-4513-9F8A-4C05CBAD98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C336FD-E841-47C9-97F6-B9547DD60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BE4A8B-39E6-479D-BF3B-A95B3582F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C6991-7130-40E3-BC5C-8C300CB0C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146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87B28-9B9A-4739-9B5F-E8E8265C8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3D72DB-A2FF-4AE9-8606-E384625362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010D6-B8DD-44A6-B3AB-3F5B3A22E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D1C80-9292-43EE-91E4-D24B94288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66200B-D361-43DA-A81C-5F68B9F91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919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AC6938-5746-4F1D-98B0-BA0481AFBE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E175BC-FD68-44BD-983A-886E31D254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D67933-3D39-4B73-B542-5E4DCACE0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4AB555-7791-49F2-BE2D-250B7ACA7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8A3BC4-722B-4492-8D7A-CE6D46E87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218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FC8542-BB5F-4806-B9B8-292EB4624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B1778F-8AD2-4800-BBCD-33C0729311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BBD8F-DDCE-4EF7-B57F-D18C7E18C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5A063E-3134-4FFD-98B1-9FBD7C2C9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74F5E1-0979-45A4-A537-332839581B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672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DFCD07-41F5-40A2-BD43-3C48A5767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DD6833-BC26-477C-82DA-F495F10934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1778A8-8144-49D7-A434-6963CEFE7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E8BD44-1514-4003-93B2-C3D2BE76AA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D2CEC7-F780-4CF6-BD65-6A592FCA0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458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BD6441-7FAB-4AA8-82C1-271C7EE8C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816C3B-8B97-47A5-B4AE-159DC11586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6BE841-B4F0-497B-8A08-E60AB6B21C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2FF301-C23E-43E0-93E1-0F2CC2971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23F22D-A062-47EA-A9B4-4DD0143BF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BF18A6-E65B-44A9-891B-3DDB25F85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18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99627-9021-43BC-9951-EFA25D58F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19CBBF-0EFA-4924-B569-41CD47E121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90BF9E-DCA2-4AA8-9449-AB482B8F5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C52F9E-370A-4BBF-BAA5-79FC5F3B8D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5987994-2689-4AE5-B65B-6DB839FB57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D9790E-5538-4694-9C50-6FCD50A22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4E2BC3-4453-4501-9D60-96069B2F3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C42628-0200-4AFC-AC74-0171F4303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282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1E0F9D-F170-4232-B727-36BAA17E26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308A98-DE08-4105-8430-2537223F0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B714B3-0028-4986-AA7B-7D7A35791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1D0D1B-65F0-4A7C-8E13-3F5CAFA45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404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152D47-61F0-43A8-BAFD-CE0E0868D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258B09-9A55-45AD-97EF-C0F8D007B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FAA32A4-5B0E-401A-9A9A-5F932E84A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540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F428E0-9AF9-4EB6-9D21-E3CBCB4A28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15151-1E0C-4EE6-A44D-8D6DDF6E98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B808B3-9405-4FF5-95AC-415865DDE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8E5F63-F554-4B53-82AE-A9F858E8C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A5A42A-447E-483C-81F8-05959ED27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3FD730-7874-4E1B-86C6-75EA24C28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036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FC3FCD-7371-4EAC-8208-16A152A95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E6F84F2-39F5-47B2-85B2-3A55EF9D0A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1CCEA4-30C2-4A2D-876B-4EED4A65AF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6E48F6-5C4B-415A-8218-CE4600141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D8162-01FC-4F55-AB6D-D1065D007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5682BD-0B9E-4F2E-8245-DEC52370F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565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456ADC-3067-486A-89B2-C628FC1EE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DE7E68-57E8-4D34-867E-D1B2366C1B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ABE9F-BE64-4F9F-8ADA-05BDB83756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4B7E2-2C7D-4818-8DFE-8E379F23CFB6}" type="datetimeFigureOut">
              <a:rPr lang="en-US" smtClean="0"/>
              <a:pPr/>
              <a:t>11/28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69D3D7-130C-43C7-BFB2-7AA0688FDB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E100BA-D312-4C93-8A3A-9EDE7A41C1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A3DF6B-AC91-4980-B42B-38A026F3F2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866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5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EDC53229-D178-4BBF-99D3-E1C2835459F4}"/>
              </a:ext>
            </a:extLst>
          </p:cNvPr>
          <p:cNvGrpSpPr/>
          <p:nvPr/>
        </p:nvGrpSpPr>
        <p:grpSpPr>
          <a:xfrm>
            <a:off x="7939812" y="449618"/>
            <a:ext cx="2880995" cy="3942715"/>
            <a:chOff x="7939812" y="449618"/>
            <a:chExt cx="2880995" cy="3942715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7306AE1-A0BF-47AC-8944-CCDBE5ED2436}"/>
                </a:ext>
              </a:extLst>
            </p:cNvPr>
            <p:cNvPicPr/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939812" y="449618"/>
              <a:ext cx="2880995" cy="39427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34A5CF5C-9DB2-4337-8FC2-5553518097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38301" y="3367088"/>
              <a:ext cx="215874" cy="265112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en-US"/>
            </a:p>
          </p:txBody>
        </p:sp>
      </p:grpSp>
      <p:pic>
        <p:nvPicPr>
          <p:cNvPr id="17" name="Picture 16">
            <a:extLst>
              <a:ext uri="{FF2B5EF4-FFF2-40B4-BE49-F238E27FC236}">
                <a16:creationId xmlns:a16="http://schemas.microsoft.com/office/drawing/2014/main" id="{C83C96D8-FFE2-498B-989D-DD32A65EF554}"/>
              </a:ext>
            </a:extLst>
          </p:cNvPr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775607" y="546986"/>
            <a:ext cx="2340506" cy="42146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6BA65FBD-EC35-4C83-9D50-6D90C01CE3E4}"/>
              </a:ext>
            </a:extLst>
          </p:cNvPr>
          <p:cNvGrpSpPr/>
          <p:nvPr/>
        </p:nvGrpSpPr>
        <p:grpSpPr>
          <a:xfrm>
            <a:off x="860061" y="719096"/>
            <a:ext cx="4876345" cy="2974018"/>
            <a:chOff x="6521889" y="1438184"/>
            <a:chExt cx="4457065" cy="249462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CA6CDBC-F913-4E45-A0C9-F975DD05DDEE}"/>
                </a:ext>
              </a:extLst>
            </p:cNvPr>
            <p:cNvPicPr/>
            <p:nvPr/>
          </p:nvPicPr>
          <p:blipFill>
            <a:blip r:embed="rId4" cstate="print"/>
            <a:srcRect t="4762"/>
            <a:stretch>
              <a:fillRect/>
            </a:stretch>
          </p:blipFill>
          <p:spPr bwMode="auto">
            <a:xfrm>
              <a:off x="6521889" y="1438184"/>
              <a:ext cx="4457065" cy="12719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C95C826-4D55-462C-8DD1-0A069B36AA5D}"/>
                </a:ext>
              </a:extLst>
            </p:cNvPr>
            <p:cNvPicPr/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521889" y="2839294"/>
              <a:ext cx="4457065" cy="10935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BD7240BB-2A91-4094-B121-BF386409B87C}"/>
              </a:ext>
            </a:extLst>
          </p:cNvPr>
          <p:cNvSpPr txBox="1"/>
          <p:nvPr/>
        </p:nvSpPr>
        <p:spPr>
          <a:xfrm>
            <a:off x="8662101" y="80286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6A1130C-24B1-404C-9067-7FB28C0A3EA1}"/>
              </a:ext>
            </a:extLst>
          </p:cNvPr>
          <p:cNvSpPr txBox="1"/>
          <p:nvPr/>
        </p:nvSpPr>
        <p:spPr>
          <a:xfrm>
            <a:off x="6043904" y="73272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D69EC4-8804-43A3-B466-E610125D32E8}"/>
              </a:ext>
            </a:extLst>
          </p:cNvPr>
          <p:cNvSpPr txBox="1"/>
          <p:nvPr/>
        </p:nvSpPr>
        <p:spPr>
          <a:xfrm>
            <a:off x="860061" y="80286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138AF33-2C47-4571-91D4-9F04B5E21B06}"/>
              </a:ext>
            </a:extLst>
          </p:cNvPr>
          <p:cNvPicPr/>
          <p:nvPr/>
        </p:nvPicPr>
        <p:blipFill>
          <a:blip r:embed="rId6" cstate="print"/>
          <a:srcRect b="9434"/>
          <a:stretch>
            <a:fillRect/>
          </a:stretch>
        </p:blipFill>
        <p:spPr bwMode="auto">
          <a:xfrm>
            <a:off x="9149266" y="3945947"/>
            <a:ext cx="1991995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0392881-F163-4C5C-B48C-0B63100A9082}"/>
              </a:ext>
            </a:extLst>
          </p:cNvPr>
          <p:cNvSpPr txBox="1"/>
          <p:nvPr/>
        </p:nvSpPr>
        <p:spPr>
          <a:xfrm>
            <a:off x="912180" y="4859033"/>
            <a:ext cx="1036764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igure S1: Missense mutation within NAD(P) transhydrogenase subunit alpha protein. (A) MSA of 11 </a:t>
            </a:r>
            <a:r>
              <a:rPr lang="en-US" sz="1400" i="1" dirty="0"/>
              <a:t>Brucella</a:t>
            </a:r>
            <a:r>
              <a:rPr lang="en-US" sz="1400" dirty="0"/>
              <a:t> transhydrogenase alpha subunit proteins (upper panel) and of 7 homologs from other Gram-negative bacteria (non-Brucella). Only the region of residues 140-165 is shown. Position 155 (marked by a red rectangle) is located in a highly conserved region. (B) A model of </a:t>
            </a:r>
            <a:r>
              <a:rPr lang="en-US" sz="1400" i="1" dirty="0"/>
              <a:t>B. </a:t>
            </a:r>
            <a:r>
              <a:rPr lang="en-US" sz="1400" i="1" dirty="0" err="1"/>
              <a:t>melitensis</a:t>
            </a:r>
            <a:r>
              <a:rPr lang="en-US" sz="1400" i="1" dirty="0"/>
              <a:t> </a:t>
            </a:r>
            <a:r>
              <a:rPr lang="en-US" sz="1400" dirty="0"/>
              <a:t>transhydrogenase alpha subunit. Protein is shown in grey ribbon, Met155 in shown in magenta sticks, surrounding residues shown in sticks and colored according to element. The </a:t>
            </a:r>
            <a:r>
              <a:rPr lang="en-US" sz="1400" dirty="0" err="1"/>
              <a:t>Prosite</a:t>
            </a:r>
            <a:r>
              <a:rPr lang="en-US" sz="1400" dirty="0"/>
              <a:t> motif is colored orange. Also shown is the substrate NADH (green sticks), which was extracted from </a:t>
            </a:r>
            <a:r>
              <a:rPr lang="en-US" sz="1400" i="1" dirty="0"/>
              <a:t>R. rubrum </a:t>
            </a:r>
            <a:r>
              <a:rPr lang="en-US" sz="1400" dirty="0"/>
              <a:t>Transhydrogenase Domain I with Bound NADH (PDB ID 1L7E) after alignment of the 2 proteins. (C) NAD(P) transhydrogenase alpha subunit is colored according to conservation. Met155 is circled in red.</a:t>
            </a:r>
          </a:p>
        </p:txBody>
      </p:sp>
    </p:spTree>
    <p:extLst>
      <p:ext uri="{BB962C8B-B14F-4D97-AF65-F5344CB8AC3E}">
        <p14:creationId xmlns:p14="http://schemas.microsoft.com/office/powerpoint/2010/main" val="909879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E7FC077-D459-41B1-9137-2B2D4767CEEB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23" t="5795" r="10899"/>
          <a:stretch/>
        </p:blipFill>
        <p:spPr bwMode="auto">
          <a:xfrm>
            <a:off x="8872269" y="195289"/>
            <a:ext cx="2388613" cy="225522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8D98166-5EC9-4554-AD1A-AACA9192F0B1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28" r="29707"/>
          <a:stretch/>
        </p:blipFill>
        <p:spPr bwMode="auto">
          <a:xfrm>
            <a:off x="8872269" y="2292064"/>
            <a:ext cx="2374023" cy="209250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197424E-E330-4321-9D50-B2B1115F7C18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40" r="26240"/>
          <a:stretch/>
        </p:blipFill>
        <p:spPr bwMode="auto">
          <a:xfrm>
            <a:off x="8885648" y="4234294"/>
            <a:ext cx="2374022" cy="201058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E287E76-21BA-4190-A0F0-A766104EBB2D}"/>
              </a:ext>
            </a:extLst>
          </p:cNvPr>
          <p:cNvSpPr txBox="1"/>
          <p:nvPr/>
        </p:nvSpPr>
        <p:spPr>
          <a:xfrm>
            <a:off x="3594296" y="96833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A0BB41-68DB-4E6B-B82A-D7BDDB37BF14}"/>
              </a:ext>
            </a:extLst>
          </p:cNvPr>
          <p:cNvSpPr txBox="1"/>
          <p:nvPr/>
        </p:nvSpPr>
        <p:spPr>
          <a:xfrm>
            <a:off x="8809514" y="249625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E885A16-9E33-4F13-A295-94A81DF4DFF0}"/>
              </a:ext>
            </a:extLst>
          </p:cNvPr>
          <p:cNvSpPr txBox="1"/>
          <p:nvPr/>
        </p:nvSpPr>
        <p:spPr>
          <a:xfrm>
            <a:off x="8778068" y="2476730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2DC001-E0D9-4105-AA8E-81CBA86947E7}"/>
              </a:ext>
            </a:extLst>
          </p:cNvPr>
          <p:cNvSpPr txBox="1"/>
          <p:nvPr/>
        </p:nvSpPr>
        <p:spPr>
          <a:xfrm>
            <a:off x="8786135" y="4461511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66835A-A869-43C5-BD54-0066299FF757}"/>
              </a:ext>
            </a:extLst>
          </p:cNvPr>
          <p:cNvSpPr txBox="1"/>
          <p:nvPr/>
        </p:nvSpPr>
        <p:spPr>
          <a:xfrm>
            <a:off x="318887" y="492707"/>
            <a:ext cx="2987466" cy="50475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Figure S2: Missense mutation within Magnesium transporter. (A) MSA of 85 </a:t>
            </a:r>
            <a:r>
              <a:rPr lang="en-GB" sz="1400" i="1" dirty="0"/>
              <a:t>Brucella</a:t>
            </a:r>
            <a:r>
              <a:rPr lang="en-GB" sz="1400" dirty="0"/>
              <a:t> Magnesium transporter sequences. Only the CBS domain is presented (residues 139-261). Thr155, marked by red rectangle, is conserved through all homologs. (B) Mg2+ transporter model structure is shown in white ribbons, </a:t>
            </a:r>
            <a:r>
              <a:rPr lang="en-GB" sz="1400" dirty="0" err="1"/>
              <a:t>Prosite</a:t>
            </a:r>
            <a:r>
              <a:rPr lang="en-GB" sz="1400" dirty="0"/>
              <a:t> CBS motifs (PS51371) are in red and yellow (139-202 and 203-261 respectively). ATP in sticks </a:t>
            </a:r>
            <a:r>
              <a:rPr lang="en-GB" sz="1400" dirty="0" err="1"/>
              <a:t>colored</a:t>
            </a:r>
            <a:r>
              <a:rPr lang="en-GB" sz="1400" dirty="0"/>
              <a:t> by atom, residue Thr155 in green sticks. Mg2+ ions in magenta spheres. (C) Zoom in on Thr155 region. The Mg2+ transporter model structure is shown in white ribbons, Thr155 and residues 6 angstroms around it are shown by spheres, </a:t>
            </a:r>
            <a:r>
              <a:rPr lang="en-GB" sz="1400" dirty="0" err="1"/>
              <a:t>colored</a:t>
            </a:r>
            <a:r>
              <a:rPr lang="en-GB" sz="1400" dirty="0"/>
              <a:t> by atoms, (Thr155 carbons in cyan). (D) </a:t>
            </a:r>
            <a:r>
              <a:rPr lang="en-GB" sz="1400" dirty="0" err="1"/>
              <a:t>Coloring</a:t>
            </a:r>
            <a:r>
              <a:rPr lang="en-GB" sz="1400" dirty="0"/>
              <a:t> according to conservation. This analysis is based on 150 homologous sequences from Uniref90. ATP is shown by sticks and </a:t>
            </a:r>
            <a:r>
              <a:rPr lang="en-GB" sz="1400" dirty="0" err="1"/>
              <a:t>colored</a:t>
            </a:r>
            <a:r>
              <a:rPr lang="en-GB" sz="1400" dirty="0"/>
              <a:t> by atom.</a:t>
            </a:r>
            <a:endParaRPr lang="en-US" sz="1400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BC2BFB7-A191-4179-B5E8-BF5EF52CBCA5}"/>
              </a:ext>
            </a:extLst>
          </p:cNvPr>
          <p:cNvGrpSpPr/>
          <p:nvPr/>
        </p:nvGrpSpPr>
        <p:grpSpPr>
          <a:xfrm>
            <a:off x="3512803" y="618957"/>
            <a:ext cx="5058815" cy="6051004"/>
            <a:chOff x="3457656" y="468928"/>
            <a:chExt cx="5058815" cy="605100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7DD6AC9-0416-4CED-94EF-51AC74D97623}"/>
                </a:ext>
              </a:extLst>
            </p:cNvPr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7656" y="468928"/>
              <a:ext cx="5058815" cy="6051004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02349032-9FF8-445A-B636-BAA015D8B3F7}"/>
                </a:ext>
              </a:extLst>
            </p:cNvPr>
            <p:cNvSpPr/>
            <p:nvPr/>
          </p:nvSpPr>
          <p:spPr>
            <a:xfrm>
              <a:off x="4703385" y="526327"/>
              <a:ext cx="64512" cy="113766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1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>
                <a:solidFill>
                  <a:srgbClr val="FF0000"/>
                </a:solidFill>
              </a:endParaRPr>
            </a:p>
          </p:txBody>
        </p:sp>
      </p:grpSp>
      <p:pic>
        <p:nvPicPr>
          <p:cNvPr id="16" name="Picture 15">
            <a:extLst>
              <a:ext uri="{FF2B5EF4-FFF2-40B4-BE49-F238E27FC236}">
                <a16:creationId xmlns:a16="http://schemas.microsoft.com/office/drawing/2014/main" id="{556116A2-E843-4677-BB99-770E7BE6749D}"/>
              </a:ext>
            </a:extLst>
          </p:cNvPr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403"/>
          <a:stretch/>
        </p:blipFill>
        <p:spPr bwMode="auto">
          <a:xfrm>
            <a:off x="8778068" y="6362089"/>
            <a:ext cx="2664460" cy="4762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611612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29AD127-E385-4D82-8FAF-FF4BF57255C8}"/>
              </a:ext>
            </a:extLst>
          </p:cNvPr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74762" y="900653"/>
            <a:ext cx="5236341" cy="15349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6F74ADA-C4B8-47FF-92FF-879CF58EE387}"/>
              </a:ext>
            </a:extLst>
          </p:cNvPr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74762" y="2543054"/>
            <a:ext cx="5140212" cy="12825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34DE681-AB13-424C-B9E0-B6B6C2735CA5}"/>
              </a:ext>
            </a:extLst>
          </p:cNvPr>
          <p:cNvPicPr/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756094" y="718910"/>
            <a:ext cx="2628900" cy="31066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0E5E43C-2A7C-4F0F-B6D3-43630B4F60AE}"/>
              </a:ext>
            </a:extLst>
          </p:cNvPr>
          <p:cNvPicPr/>
          <p:nvPr/>
        </p:nvPicPr>
        <p:blipFill>
          <a:blip r:embed="rId5" cstate="print"/>
          <a:srcRect b="9434"/>
          <a:stretch>
            <a:fillRect/>
          </a:stretch>
        </p:blipFill>
        <p:spPr bwMode="auto">
          <a:xfrm>
            <a:off x="8626114" y="3960550"/>
            <a:ext cx="1993900" cy="460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D5A6241-E55E-4EDE-9AE4-A5549AD869F9}"/>
              </a:ext>
            </a:extLst>
          </p:cNvPr>
          <p:cNvSpPr txBox="1"/>
          <p:nvPr/>
        </p:nvSpPr>
        <p:spPr>
          <a:xfrm>
            <a:off x="612411" y="349578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6B02F23-6579-4EE3-924E-C4B89A7F6A80}"/>
              </a:ext>
            </a:extLst>
          </p:cNvPr>
          <p:cNvSpPr txBox="1"/>
          <p:nvPr/>
        </p:nvSpPr>
        <p:spPr>
          <a:xfrm>
            <a:off x="5779452" y="280111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BEED7F5-F125-4013-AA1C-8E6EDA427F92}"/>
              </a:ext>
            </a:extLst>
          </p:cNvPr>
          <p:cNvSpPr txBox="1"/>
          <p:nvPr/>
        </p:nvSpPr>
        <p:spPr>
          <a:xfrm>
            <a:off x="8699136" y="264952"/>
            <a:ext cx="390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0EB0811-16F5-4154-A208-5DEDB3425CAA}"/>
              </a:ext>
            </a:extLst>
          </p:cNvPr>
          <p:cNvSpPr txBox="1"/>
          <p:nvPr/>
        </p:nvSpPr>
        <p:spPr>
          <a:xfrm>
            <a:off x="595632" y="4489668"/>
            <a:ext cx="1036764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Figure S3: Missense mutation within the MFS transporter protein. (A) MSA of 12 Brucella MFS proteins (upper panel) and of 6 homologs from other Gram-negative bacteria (non-</a:t>
            </a:r>
            <a:r>
              <a:rPr lang="en-GB" sz="1400" i="1" dirty="0"/>
              <a:t>Brucella</a:t>
            </a:r>
            <a:r>
              <a:rPr lang="en-GB" sz="1400" dirty="0"/>
              <a:t>). Only the region of residues 345-375 is shown. Position 357 (marked by a red rectangle) is located in highly conserved region. (B) A model of B. </a:t>
            </a:r>
            <a:r>
              <a:rPr lang="en-GB" sz="1400" dirty="0" err="1"/>
              <a:t>melitensis</a:t>
            </a:r>
            <a:r>
              <a:rPr lang="en-GB" sz="1400" dirty="0"/>
              <a:t> MFS protein. Protein is shown in grey ribbon, Pro357 in shown in magenta sticks, surrounding residues shown in sticks and </a:t>
            </a:r>
            <a:r>
              <a:rPr lang="en-GB" sz="1400" dirty="0" err="1"/>
              <a:t>colored</a:t>
            </a:r>
            <a:r>
              <a:rPr lang="en-GB" sz="1400" dirty="0"/>
              <a:t> according to element. Also shown is the substrate chloramphenicol (green sticks), which was extracted from E. coli multidrug transporter </a:t>
            </a:r>
            <a:r>
              <a:rPr lang="en-GB" sz="1400" dirty="0" err="1"/>
              <a:t>MdfA</a:t>
            </a:r>
            <a:r>
              <a:rPr lang="en-GB" sz="1400" dirty="0"/>
              <a:t> after alignment of the 2 proteins. (C) MFS protein is </a:t>
            </a:r>
            <a:r>
              <a:rPr lang="en-GB" sz="1400" dirty="0" err="1"/>
              <a:t>colored</a:t>
            </a:r>
            <a:r>
              <a:rPr lang="en-GB" sz="1400" dirty="0"/>
              <a:t> according to conservation. Pro357 is circled in red.</a:t>
            </a:r>
            <a:endParaRPr lang="en-US" sz="1400" dirty="0"/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DAAC569E-5DA7-4453-8335-E121EFB70176}"/>
              </a:ext>
            </a:extLst>
          </p:cNvPr>
          <p:cNvGrpSpPr/>
          <p:nvPr/>
        </p:nvGrpSpPr>
        <p:grpSpPr>
          <a:xfrm>
            <a:off x="8529985" y="552450"/>
            <a:ext cx="2333732" cy="3408100"/>
            <a:chOff x="8529985" y="552450"/>
            <a:chExt cx="2333732" cy="340810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F559835-4D63-4A11-9E18-B1E249989F2B}"/>
                </a:ext>
              </a:extLst>
            </p:cNvPr>
            <p:cNvPicPr/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8529985" y="552450"/>
              <a:ext cx="2333732" cy="3408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87763B20-23F2-4F56-97FA-E847C7ABA2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61212" y="1494018"/>
              <a:ext cx="212090" cy="255905"/>
            </a:xfrm>
            <a:prstGeom prst="ellips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010475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F4FD606C-F178-4B67-A962-8BF74733ECE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6814" y="288138"/>
            <a:ext cx="10465870" cy="435133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B6B7703-4F5C-479D-9814-AB45AC3A66D8}"/>
              </a:ext>
            </a:extLst>
          </p:cNvPr>
          <p:cNvSpPr txBox="1"/>
          <p:nvPr/>
        </p:nvSpPr>
        <p:spPr>
          <a:xfrm flipH="1">
            <a:off x="1322758" y="4720396"/>
            <a:ext cx="9673047" cy="9541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just"/>
            <a:r>
              <a:rPr lang="en-US" sz="1400" dirty="0"/>
              <a:t>Figure S4. </a:t>
            </a:r>
            <a:r>
              <a:rPr lang="en-US" sz="1400" i="1" dirty="0"/>
              <a:t>In vitro </a:t>
            </a:r>
            <a:r>
              <a:rPr lang="en-US" sz="1400" dirty="0"/>
              <a:t>stress survival of the natural rough </a:t>
            </a:r>
            <a:r>
              <a:rPr lang="en-US" sz="1400" i="1" dirty="0"/>
              <a:t>B. </a:t>
            </a:r>
            <a:r>
              <a:rPr lang="en-US" sz="1400" i="1" dirty="0" err="1"/>
              <a:t>melitensis</a:t>
            </a:r>
            <a:r>
              <a:rPr lang="en-US" sz="1400" i="1" dirty="0"/>
              <a:t> </a:t>
            </a:r>
            <a:r>
              <a:rPr lang="en-US" sz="1400" dirty="0"/>
              <a:t>Rev.1 71036 and 44457 vaccine strains.  The survival of the natural rough </a:t>
            </a:r>
            <a:r>
              <a:rPr lang="en-US" sz="1400" i="1" dirty="0"/>
              <a:t>B. </a:t>
            </a:r>
            <a:r>
              <a:rPr lang="en-US" sz="1400" i="1" dirty="0" err="1"/>
              <a:t>melitensis</a:t>
            </a:r>
            <a:r>
              <a:rPr lang="en-US" sz="1400" i="1" dirty="0"/>
              <a:t> </a:t>
            </a:r>
            <a:r>
              <a:rPr lang="en-US" sz="1400" dirty="0"/>
              <a:t>Rev.1 71036 and 44457 vaccine strains under acidic (pH4.4, 3 h; A) and oxidative (10 </a:t>
            </a:r>
            <a:r>
              <a:rPr lang="en-US" sz="1400" dirty="0" err="1"/>
              <a:t>mM</a:t>
            </a:r>
            <a:r>
              <a:rPr lang="en-US" sz="1400" dirty="0"/>
              <a:t> H</a:t>
            </a:r>
            <a:r>
              <a:rPr lang="en-US" sz="1400" baseline="-25000" dirty="0"/>
              <a:t>2</a:t>
            </a:r>
            <a:r>
              <a:rPr lang="en-US" sz="1400" dirty="0"/>
              <a:t>O</a:t>
            </a:r>
            <a:r>
              <a:rPr lang="en-US" sz="1400" baseline="-25000" dirty="0"/>
              <a:t>2</a:t>
            </a:r>
            <a:r>
              <a:rPr lang="en-US" sz="1400" dirty="0"/>
              <a:t>, 2 h; B) stress conditions was investigated as described in Materials and Methods. Strain 71036 exhibited a decrease of viable CFU/ml, compared to strain 44457 under oxidative stress conditions (</a:t>
            </a:r>
            <a:r>
              <a:rPr lang="en-US" sz="1400" i="1" dirty="0"/>
              <a:t>P</a:t>
            </a:r>
            <a:r>
              <a:rPr lang="en-US" sz="1400" dirty="0"/>
              <a:t>&lt;0.0001, unpaired t test).</a:t>
            </a:r>
            <a:endParaRPr lang="he-IL" sz="1400" dirty="0"/>
          </a:p>
        </p:txBody>
      </p:sp>
    </p:spTree>
    <p:extLst>
      <p:ext uri="{BB962C8B-B14F-4D97-AF65-F5344CB8AC3E}">
        <p14:creationId xmlns:p14="http://schemas.microsoft.com/office/powerpoint/2010/main" val="2990861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5</TotalTime>
  <Words>587</Words>
  <Application>Microsoft Office PowerPoint</Application>
  <PresentationFormat>Widescreen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li</dc:creator>
  <cp:lastModifiedBy>דויד קורנספן</cp:lastModifiedBy>
  <cp:revision>22</cp:revision>
  <dcterms:created xsi:type="dcterms:W3CDTF">2020-09-03T09:24:21Z</dcterms:created>
  <dcterms:modified xsi:type="dcterms:W3CDTF">2020-11-28T19:28:11Z</dcterms:modified>
</cp:coreProperties>
</file>